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5" r:id="rId2"/>
  </p:sldIdLst>
  <p:sldSz cx="6858000" cy="9144000" type="screen4x3"/>
  <p:notesSz cx="6797675" cy="9926638"/>
  <p:defaultTextStyle>
    <a:defPPr>
      <a:defRPr lang="en-A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92" userDrawn="1">
          <p15:clr>
            <a:srgbClr val="A4A3A4"/>
          </p15:clr>
        </p15:guide>
        <p15:guide id="2" pos="61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082" autoAdjust="0"/>
    <p:restoredTop sz="95332" autoAdjust="0"/>
  </p:normalViewPr>
  <p:slideViewPr>
    <p:cSldViewPr snapToGrid="0" showGuides="1">
      <p:cViewPr varScale="1">
        <p:scale>
          <a:sx n="66" d="100"/>
          <a:sy n="66" d="100"/>
        </p:scale>
        <p:origin x="2933" y="58"/>
      </p:cViewPr>
      <p:guideLst>
        <p:guide orient="horz" pos="3492"/>
        <p:guide pos="61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466DFD-1D01-46B0-99D4-7752715C965A}" type="datetimeFigureOut">
              <a:rPr lang="en-AU" smtClean="0"/>
              <a:t>30/10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039207-2A76-4BA9-9A52-13724CD8AF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898452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DD717D-9932-4A07-A6DE-333CD40ED279}" type="datetimeFigureOut">
              <a:rPr lang="en-AU" smtClean="0"/>
              <a:t>30/10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805E6-A15E-4820-9543-010104295D1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1235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7013"/>
            <a:ext cx="5143500" cy="31829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188"/>
            <a:ext cx="5143500" cy="220821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999F16-BBFC-4758-9715-BA4F54367DD6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179624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78B14B4-FFF2-4984-824D-E6316144EFAB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513222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4B26BC9-1754-4D92-8F55-86D53E042BA1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462701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6C781A-8F8C-470E-BCFA-7CAF2C9528D9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78161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313" y="2279650"/>
            <a:ext cx="5915025" cy="38036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8313" y="6119813"/>
            <a:ext cx="5915025" cy="2000250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95238BB-B4A5-4433-ABBE-091F4D599273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190254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9F43C1-46BE-4E56-A1DF-5DD79BF46FF9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15495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487363"/>
            <a:ext cx="5915025" cy="17668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3075" y="2241550"/>
            <a:ext cx="2900363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075" y="3340100"/>
            <a:ext cx="2900363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0"/>
            <a:ext cx="2916237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6237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D5FD93E-75EE-434B-B31D-885821BA5F5A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070946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FB3966B-BE84-4591-802D-CE8CF2EF74CF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381060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6F5F80-D43C-4140-9477-CCC13E2EBA70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81262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37F84CC-3C95-474D-AE0E-4C9320E2181C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988804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770E0DB-4C24-4196-A9E4-ED5BCB016747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939221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ext styles</a:t>
            </a:r>
          </a:p>
          <a:p>
            <a:pPr lvl="1"/>
            <a:r>
              <a:rPr lang="en-AU" altLang="en-US" smtClean="0"/>
              <a:t>Second level</a:t>
            </a:r>
          </a:p>
          <a:p>
            <a:pPr lvl="2"/>
            <a:r>
              <a:rPr lang="en-AU" altLang="en-US" smtClean="0"/>
              <a:t>Third level</a:t>
            </a:r>
          </a:p>
          <a:p>
            <a:pPr lvl="3"/>
            <a:r>
              <a:rPr lang="en-AU" altLang="en-US" smtClean="0"/>
              <a:t>Fourth level</a:t>
            </a:r>
          </a:p>
          <a:p>
            <a:pPr lvl="4"/>
            <a:r>
              <a:rPr lang="en-AU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AU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AU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6AF1F741-95FE-47FB-A53E-DF0ABCAECF23}" type="slidenum">
              <a:rPr lang="en-AU" altLang="en-US"/>
              <a:pPr/>
              <a:t>‹#›</a:t>
            </a:fld>
            <a:endParaRPr lang="en-AU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866277" y="5953884"/>
            <a:ext cx="536448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200" b="1" dirty="0">
                <a:latin typeface="Times New Roman" panose="02020603050405020304" pitchFamily="18" charset="0"/>
                <a:ea typeface="MS Mincho"/>
              </a:rPr>
              <a:t>Supplementary Figure S1: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Effect of PTH and rhSCL treatment on gene expression in human bone. </a:t>
            </a:r>
            <a:r>
              <a:rPr lang="en-AU" sz="1200" dirty="0" smtClean="0">
                <a:latin typeface="Times New Roman" panose="02020603050405020304" pitchFamily="18" charset="0"/>
                <a:ea typeface="MS Mincho"/>
              </a:rPr>
              <a:t>Cancellous 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bone fragments prepared as described in Materials and Methods were treated with rhPTH</a:t>
            </a:r>
            <a:r>
              <a:rPr lang="en-AU" sz="1200" baseline="-25000" dirty="0">
                <a:latin typeface="Times New Roman" panose="02020603050405020304" pitchFamily="18" charset="0"/>
                <a:ea typeface="MS Mincho"/>
              </a:rPr>
              <a:t>1-34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(100 ng/ml) or rhSCL (50 ng/ml) for 24h. Bone was processed by total RNA and gene expression measured by real-time RT-PCR for A)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FGF23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, B)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PHEX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, C)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DM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, D)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ENP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, E)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GALNT3 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mRNA expression. Gene expression was normalised to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GAPDH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levels and data described as mean fold-change </a:t>
            </a:r>
            <a:r>
              <a:rPr lang="en-AU" sz="1200" dirty="0">
                <a:latin typeface="Times New Roman" panose="02020603050405020304" pitchFamily="18" charset="0"/>
                <a:ea typeface="MS Mincho"/>
                <a:sym typeface="Symbol" panose="05050102010706020507" pitchFamily="18" charset="2"/>
              </a:rPr>
              <a:t>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SEM relative to the untreated normal control (NC). Significant difference to the reference level is depicted by * p&lt;0.05; ** p&lt;0.01; *** p&lt;0.001.</a:t>
            </a:r>
          </a:p>
          <a:p>
            <a:endParaRPr lang="en-AU" sz="12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5587" y="476798"/>
            <a:ext cx="4285859" cy="538933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82</TotalTime>
  <Words>12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MS Mincho</vt:lpstr>
      <vt:lpstr>Symbol</vt:lpstr>
      <vt:lpstr>Times New Roman</vt:lpstr>
      <vt:lpstr>Default Desig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ald Atkins</dc:creator>
  <cp:lastModifiedBy>Gerald Atkins</cp:lastModifiedBy>
  <cp:revision>371</cp:revision>
  <cp:lastPrinted>2018-05-24T08:03:24Z</cp:lastPrinted>
  <dcterms:created xsi:type="dcterms:W3CDTF">1601-01-01T00:00:00Z</dcterms:created>
  <dcterms:modified xsi:type="dcterms:W3CDTF">2020-10-29T23:53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